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2" d="100"/>
          <a:sy n="92" d="100"/>
        </p:scale>
        <p:origin x="1848" y="-17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5631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79012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42548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82075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41412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7641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58528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4917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0533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4901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72340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8F04CE-12B6-4035-A611-0183351CA42B}" type="datetimeFigureOut">
              <a:rPr lang="zh-TW" altLang="en-US" smtClean="0"/>
              <a:t>2023/10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10354-6732-4733-B95D-82DAE5226D9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4826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F4E72776-FB29-7E4D-1F4F-FD3FE7AE1C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2369113"/>
              </p:ext>
            </p:extLst>
          </p:nvPr>
        </p:nvGraphicFramePr>
        <p:xfrm>
          <a:off x="325075" y="2466549"/>
          <a:ext cx="6120681" cy="1919738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0831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66040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TW" altLang="en-US" sz="18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ing region</a:t>
                      </a:r>
                      <a:endParaRPr lang="zh-TW" altLang="en-US" sz="18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  <a:r>
                        <a:rPr lang="en-US" altLang="zh-TW" sz="18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umber</a:t>
                      </a:r>
                      <a:endParaRPr lang="zh-TW" altLang="en-US" sz="1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TW" sz="18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rget Sequences</a:t>
                      </a:r>
                      <a:endParaRPr lang="zh-TW" altLang="en-US" sz="18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1549"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800" b="1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KM2</a:t>
                      </a:r>
                      <a:endParaRPr lang="zh-TW" altLang="en-US" sz="1800" b="1" kern="120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S</a:t>
                      </a:r>
                      <a:endParaRPr lang="zh-TW" alt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zh-TW" altLang="en-US" sz="2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Arial" pitchFamily="34" charset="0"/>
                          <a:cs typeface="Arial" pitchFamily="34" charset="0"/>
                        </a:rPr>
                        <a:t>GTTCGGAGGTTTGATGAAATC</a:t>
                      </a: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5280">
                <a:tc vMerge="1">
                  <a:txBody>
                    <a:bodyPr/>
                    <a:lstStyle/>
                    <a:p>
                      <a:endParaRPr lang="zh-TW" alt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’UTR</a:t>
                      </a:r>
                      <a:endParaRPr lang="zh-TW" alt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zh-TW" altLang="en-US" sz="2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>
                          <a:latin typeface="Arial" pitchFamily="34" charset="0"/>
                          <a:cs typeface="Arial" pitchFamily="34" charset="0"/>
                        </a:rPr>
                        <a:t>CAACGCTTGTAGAACTCACTC</a:t>
                      </a: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1549">
                <a:tc vMerge="1">
                  <a:txBody>
                    <a:bodyPr/>
                    <a:lstStyle/>
                    <a:p>
                      <a:endParaRPr lang="zh-TW" alt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600" b="1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S</a:t>
                      </a:r>
                      <a:endParaRPr lang="zh-TW" altLang="en-US" sz="16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b="1" dirty="0">
                          <a:latin typeface="Arial" pitchFamily="34" charset="0"/>
                          <a:cs typeface="Arial" pitchFamily="34" charset="0"/>
                        </a:rPr>
                        <a:t>C</a:t>
                      </a:r>
                      <a:endParaRPr lang="zh-TW" altLang="en-US" sz="2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Arial" pitchFamily="34" charset="0"/>
                          <a:cs typeface="Arial" pitchFamily="34" charset="0"/>
                        </a:rPr>
                        <a:t>CTTTCCTGTGTGTACTCTGTC</a:t>
                      </a:r>
                      <a:endParaRPr lang="zh-TW" altLang="en-US" sz="14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11F78095-BA08-E67A-D667-1525FA4309A2}"/>
              </a:ext>
            </a:extLst>
          </p:cNvPr>
          <p:cNvSpPr/>
          <p:nvPr/>
        </p:nvSpPr>
        <p:spPr>
          <a:xfrm>
            <a:off x="325075" y="685959"/>
            <a:ext cx="605822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>
                <a:latin typeface="Arial" pitchFamily="34" charset="0"/>
                <a:cs typeface="Arial" pitchFamily="34" charset="0"/>
              </a:rPr>
              <a:t>Table S1. </a:t>
            </a:r>
            <a:r>
              <a:rPr lang="en-US" altLang="zh-TW" dirty="0">
                <a:latin typeface="Arial" pitchFamily="34" charset="0"/>
                <a:cs typeface="Arial" pitchFamily="34" charset="0"/>
              </a:rPr>
              <a:t>Sequence of </a:t>
            </a:r>
            <a:r>
              <a:rPr lang="en-US" altLang="zh-TW" dirty="0" err="1">
                <a:latin typeface="Arial" pitchFamily="34" charset="0"/>
                <a:cs typeface="Arial" pitchFamily="34" charset="0"/>
              </a:rPr>
              <a:t>shRNA</a:t>
            </a:r>
            <a:r>
              <a:rPr lang="en-US" altLang="zh-TW" dirty="0">
                <a:latin typeface="Arial" pitchFamily="34" charset="0"/>
                <a:cs typeface="Arial" pitchFamily="34" charset="0"/>
              </a:rPr>
              <a:t> Vectors</a:t>
            </a:r>
          </a:p>
          <a:p>
            <a:r>
              <a:rPr lang="en-US" altLang="zh-TW" dirty="0">
                <a:latin typeface="Arial" pitchFamily="34" charset="0"/>
                <a:cs typeface="Arial" pitchFamily="34" charset="0"/>
              </a:rPr>
              <a:t>Vector in shRNA clone A (pLKO.1), Clone B (pLKO_TRC005) and clone C (pLKO_TRC005)</a:t>
            </a:r>
            <a:endParaRPr lang="zh-TW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8867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>
            <a:extLst>
              <a:ext uri="{FF2B5EF4-FFF2-40B4-BE49-F238E27FC236}">
                <a16:creationId xmlns:a16="http://schemas.microsoft.com/office/drawing/2014/main" id="{5E59A2B4-DCDB-51AD-0AB0-C5D19B7D0CB4}"/>
              </a:ext>
            </a:extLst>
          </p:cNvPr>
          <p:cNvSpPr txBox="1"/>
          <p:nvPr/>
        </p:nvSpPr>
        <p:spPr>
          <a:xfrm>
            <a:off x="379806" y="888583"/>
            <a:ext cx="5040675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TW" b="1" dirty="0">
                <a:latin typeface="Arial" pitchFamily="34" charset="0"/>
                <a:cs typeface="Arial" pitchFamily="34" charset="0"/>
              </a:rPr>
              <a:t>Table S2 : Primers used in the present study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678FAE40-3A62-078C-56EC-39A3294453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1631165"/>
              </p:ext>
            </p:extLst>
          </p:nvPr>
        </p:nvGraphicFramePr>
        <p:xfrm>
          <a:off x="551401" y="2095910"/>
          <a:ext cx="5267960" cy="34434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48799">
                  <a:extLst>
                    <a:ext uri="{9D8B030D-6E8A-4147-A177-3AD203B41FA5}">
                      <a16:colId xmlns:a16="http://schemas.microsoft.com/office/drawing/2014/main" val="3318070483"/>
                    </a:ext>
                  </a:extLst>
                </a:gridCol>
                <a:gridCol w="4219161">
                  <a:extLst>
                    <a:ext uri="{9D8B030D-6E8A-4147-A177-3AD203B41FA5}">
                      <a16:colId xmlns:a16="http://schemas.microsoft.com/office/drawing/2014/main" val="4019833490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Acyl CoA dehydrogenase(C4-C12)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14708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AGAGCCTGGGAACTTGGTTT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7255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CCTCAGTCATTCTCCCCAAA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9525136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Enoyl-CoA hydrata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16322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GCATTCCGTATCTTGGGAGA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96650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GCTCCAGTTGGGGAATATCA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183513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Hadroxy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acyl-CoA </a:t>
                      </a: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dehydrohena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5965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AGCTAATGCCACCACCAGAC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9769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CCTGATTGCTTCCATGAGGT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1608198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Hadroxy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acyl-CoA </a:t>
                      </a: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dehydrohenase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B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6836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GTTAATCATGGCGGAGGAAA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47475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CCAAAATCTGACCCGAGAAA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607841"/>
                  </a:ext>
                </a:extLst>
              </a:tr>
            </a:tbl>
          </a:graphicData>
        </a:graphic>
      </p:graphicFrame>
      <p:sp>
        <p:nvSpPr>
          <p:cNvPr id="3" name="文字方塊 2">
            <a:extLst>
              <a:ext uri="{FF2B5EF4-FFF2-40B4-BE49-F238E27FC236}">
                <a16:creationId xmlns:a16="http://schemas.microsoft.com/office/drawing/2014/main" id="{5634E963-7959-6A15-67F2-B5B4F11A2864}"/>
              </a:ext>
            </a:extLst>
          </p:cNvPr>
          <p:cNvSpPr txBox="1"/>
          <p:nvPr/>
        </p:nvSpPr>
        <p:spPr>
          <a:xfrm flipH="1">
            <a:off x="551401" y="1622689"/>
            <a:ext cx="252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800" b="1" dirty="0">
                <a:effectLst/>
                <a:latin typeface="Symbol" panose="05050102010706020507" pitchFamily="18" charset="2"/>
                <a:ea typeface="標楷體" panose="03000509000000000000" pitchFamily="65" charset="-120"/>
                <a:cs typeface="Times New Roman" panose="02020603050405020304" pitchFamily="18" charset="0"/>
              </a:rPr>
              <a:t>b</a:t>
            </a:r>
            <a:r>
              <a:rPr lang="en-US" altLang="zh-TW" sz="1800" b="1" dirty="0">
                <a:effectLst/>
                <a:latin typeface="Times New Roman" panose="02020603050405020304" pitchFamily="18" charset="0"/>
                <a:ea typeface="標楷體" panose="03000509000000000000" pitchFamily="65" charset="-120"/>
              </a:rPr>
              <a:t>-oxidation-Human</a:t>
            </a:r>
            <a:endParaRPr lang="zh-TW" altLang="en-US" dirty="0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685777EE-59EE-A863-5529-393B5D24C57A}"/>
              </a:ext>
            </a:extLst>
          </p:cNvPr>
          <p:cNvSpPr txBox="1"/>
          <p:nvPr/>
        </p:nvSpPr>
        <p:spPr>
          <a:xfrm>
            <a:off x="551401" y="6159174"/>
            <a:ext cx="45216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800" b="1" dirty="0">
                <a:effectLst/>
                <a:latin typeface="Times New Roman" panose="02020603050405020304" pitchFamily="18" charset="0"/>
                <a:ea typeface="標楷體" panose="03000509000000000000" pitchFamily="65" charset="-120"/>
              </a:rPr>
              <a:t>Pentose phosphate pathway-Human</a:t>
            </a:r>
            <a:endParaRPr lang="zh-TW" altLang="en-US" dirty="0"/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414667C3-88DC-E026-0784-208F501297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1731613"/>
              </p:ext>
            </p:extLst>
          </p:nvPr>
        </p:nvGraphicFramePr>
        <p:xfrm>
          <a:off x="551401" y="6652607"/>
          <a:ext cx="5267960" cy="172174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57300">
                  <a:extLst>
                    <a:ext uri="{9D8B030D-6E8A-4147-A177-3AD203B41FA5}">
                      <a16:colId xmlns:a16="http://schemas.microsoft.com/office/drawing/2014/main" val="4002058834"/>
                    </a:ext>
                  </a:extLst>
                </a:gridCol>
                <a:gridCol w="4010660">
                  <a:extLst>
                    <a:ext uri="{9D8B030D-6E8A-4147-A177-3AD203B41FA5}">
                      <a16:colId xmlns:a16="http://schemas.microsoft.com/office/drawing/2014/main" val="3879471552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Transketolase (TK)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7226274"/>
                  </a:ext>
                </a:extLst>
              </a:tr>
              <a:tr h="8867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CACCGTGGAGGACCATTATT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7495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GCATCCCTGTCGATACCAAA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6381562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 err="1">
                          <a:solidFill>
                            <a:schemeClr val="tx1"/>
                          </a:solidFill>
                          <a:effectLst/>
                        </a:rPr>
                        <a:t>Transaldolase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 (TA)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10905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GGCTGTGACTTCCTCACCAT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79268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5’-GTGACACCAACGGAAAGACT-3’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3106634"/>
                  </a:ext>
                </a:extLst>
              </a:tr>
            </a:tbl>
          </a:graphicData>
        </a:graphic>
      </p:graphicFrame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0F7CFE5E-8424-61C4-3603-CA0A548EB4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4316348"/>
              </p:ext>
            </p:extLst>
          </p:nvPr>
        </p:nvGraphicFramePr>
        <p:xfrm>
          <a:off x="551401" y="9487562"/>
          <a:ext cx="5267960" cy="86087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57300">
                  <a:extLst>
                    <a:ext uri="{9D8B030D-6E8A-4147-A177-3AD203B41FA5}">
                      <a16:colId xmlns:a16="http://schemas.microsoft.com/office/drawing/2014/main" val="4002058834"/>
                    </a:ext>
                  </a:extLst>
                </a:gridCol>
                <a:gridCol w="4010660">
                  <a:extLst>
                    <a:ext uri="{9D8B030D-6E8A-4147-A177-3AD203B41FA5}">
                      <a16:colId xmlns:a16="http://schemas.microsoft.com/office/drawing/2014/main" val="3879471552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ibosomal protein s13 (RPS13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7226274"/>
                  </a:ext>
                </a:extLst>
              </a:tr>
              <a:tr h="8867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Forword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TW" sz="1400" dirty="0"/>
                        <a:t>5'-ACGACGTGAAGGAGCAGATT-3'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7495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</a:rPr>
                        <a:t>Reverse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TW" sz="1400" dirty="0"/>
                        <a:t>5'-TCTTCAGGAAGATCAGGAGCA-3'</a:t>
                      </a:r>
                      <a:endParaRPr lang="zh-TW" sz="12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6381562"/>
                  </a:ext>
                </a:extLst>
              </a:tr>
            </a:tbl>
          </a:graphicData>
        </a:graphic>
      </p:graphicFrame>
      <p:sp>
        <p:nvSpPr>
          <p:cNvPr id="11" name="文字方塊 10">
            <a:extLst>
              <a:ext uri="{FF2B5EF4-FFF2-40B4-BE49-F238E27FC236}">
                <a16:creationId xmlns:a16="http://schemas.microsoft.com/office/drawing/2014/main" id="{8F08FC8B-41BE-4A49-873E-237BC1C37B32}"/>
              </a:ext>
            </a:extLst>
          </p:cNvPr>
          <p:cNvSpPr txBox="1"/>
          <p:nvPr/>
        </p:nvSpPr>
        <p:spPr>
          <a:xfrm>
            <a:off x="551401" y="8987041"/>
            <a:ext cx="45216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800" b="1" dirty="0">
                <a:effectLst/>
                <a:latin typeface="Times New Roman" panose="02020603050405020304" pitchFamily="18" charset="0"/>
                <a:ea typeface="標楷體" panose="03000509000000000000" pitchFamily="65" charset="-120"/>
              </a:rPr>
              <a:t>Internal control-Human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651454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5E433657-4F85-F1D1-D0E5-1BFBD7AA60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5518603"/>
              </p:ext>
            </p:extLst>
          </p:nvPr>
        </p:nvGraphicFramePr>
        <p:xfrm>
          <a:off x="226398" y="2188765"/>
          <a:ext cx="6452119" cy="4611046"/>
        </p:xfrm>
        <a:graphic>
          <a:graphicData uri="http://schemas.openxmlformats.org/drawingml/2006/table">
            <a:tbl>
              <a:tblPr/>
              <a:tblGrid>
                <a:gridCol w="23076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282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3414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600" b="1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Name</a:t>
                      </a:r>
                      <a:endParaRPr lang="zh-TW" sz="16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600" b="1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pecies</a:t>
                      </a:r>
                      <a:endParaRPr lang="zh-TW" sz="16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600" b="1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Vendor</a:t>
                      </a:r>
                      <a:endParaRPr lang="zh-TW" sz="16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600" b="1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pplications</a:t>
                      </a:r>
                      <a:endParaRPr lang="zh-TW" sz="16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735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sz="1400" b="1" kern="100" dirty="0" err="1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Involucrin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Mouse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Sigma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735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LDH-A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/IHC/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735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(Total)PDHA1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/IHC/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735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PKM2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 err="1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GeneTex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437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sz="1400" b="1" kern="100" dirty="0">
                          <a:effectLst/>
                          <a:latin typeface="Symbol" panose="05050102010706020507" pitchFamily="18" charset="2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-actin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Mouse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Sigma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735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Histone H3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 err="1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GeneTex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p-AMPK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T-AMPK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p-LKB1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T-LKB1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2459849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p-ERK1/2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5635001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T-ERK1/2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815446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p-Akt(T308)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1951348"/>
                  </a:ext>
                </a:extLst>
              </a:tr>
              <a:tr h="22879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T-Akt</a:t>
                      </a:r>
                      <a:endParaRPr lang="zh-TW" sz="14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Rabbit</a:t>
                      </a:r>
                      <a:endParaRPr lang="zh-TW" sz="1400" b="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Cell signaling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5078323"/>
                  </a:ext>
                </a:extLst>
              </a:tr>
              <a:tr h="250184"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Anti-SREBP1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Mouse</a:t>
                      </a:r>
                      <a:endParaRPr lang="zh-TW" sz="1400" b="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Santa Cruz</a:t>
                      </a:r>
                      <a:endParaRPr lang="zh-TW" sz="1400" b="1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標楷體" panose="03000509000000000000" pitchFamily="65" charset="-120"/>
                          <a:cs typeface="Arial" panose="020B0604020202020204" pitchFamily="34" charset="0"/>
                        </a:rPr>
                        <a:t>WB</a:t>
                      </a:r>
                      <a:endParaRPr lang="zh-TW" sz="1400" b="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590589"/>
                  </a:ext>
                </a:extLst>
              </a:tr>
            </a:tbl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64740C79-F043-9AC8-A8A5-854562E582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0186772"/>
              </p:ext>
            </p:extLst>
          </p:nvPr>
        </p:nvGraphicFramePr>
        <p:xfrm>
          <a:off x="159635" y="7861300"/>
          <a:ext cx="6501901" cy="1310640"/>
        </p:xfrm>
        <a:graphic>
          <a:graphicData uri="http://schemas.openxmlformats.org/drawingml/2006/table">
            <a:tbl>
              <a:tblPr/>
              <a:tblGrid>
                <a:gridCol w="25827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62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6118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170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672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Name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Species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Vendor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TW" sz="1400" b="1" kern="100" dirty="0">
                          <a:latin typeface="Arial" panose="020B0604020202020204" pitchFamily="34" charset="0"/>
                          <a:ea typeface="新細明體"/>
                          <a:cs typeface="Arial" panose="020B0604020202020204" pitchFamily="34" charset="0"/>
                        </a:rPr>
                        <a:t>Applications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720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mouse HRP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1" kern="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720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nti-rabbit HRP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1" kern="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WB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5115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b="1" kern="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AlexaFluor</a:t>
                      </a:r>
                      <a:r>
                        <a:rPr lang="en-US" sz="1400" b="1" kern="0" baseline="3000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4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 594 Anti-Rabbit </a:t>
                      </a:r>
                      <a:endParaRPr lang="zh-TW" sz="14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Donkey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Jackson </a:t>
                      </a:r>
                      <a:r>
                        <a:rPr lang="en-US" sz="1200" b="1" kern="0" dirty="0" err="1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mmunoResearch</a:t>
                      </a:r>
                      <a:endParaRPr lang="zh-TW" sz="1200" b="1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latin typeface="Arial" panose="020B0604020202020204" pitchFamily="34" charset="0"/>
                          <a:ea typeface="標楷體"/>
                          <a:cs typeface="Arial" panose="020B0604020202020204" pitchFamily="34" charset="0"/>
                        </a:rPr>
                        <a:t>IF</a:t>
                      </a:r>
                      <a:endParaRPr lang="zh-TW" sz="1400" kern="100" dirty="0">
                        <a:latin typeface="Arial" panose="020B0604020202020204" pitchFamily="34" charset="0"/>
                        <a:ea typeface="新細明體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7937554"/>
                  </a:ext>
                </a:extLst>
              </a:tr>
            </a:tbl>
          </a:graphicData>
        </a:graphic>
      </p:graphicFrame>
      <p:sp>
        <p:nvSpPr>
          <p:cNvPr id="6" name="文字方塊 5">
            <a:extLst>
              <a:ext uri="{FF2B5EF4-FFF2-40B4-BE49-F238E27FC236}">
                <a16:creationId xmlns:a16="http://schemas.microsoft.com/office/drawing/2014/main" id="{C9BC3E88-F7F3-8455-34AF-96278B6274A7}"/>
              </a:ext>
            </a:extLst>
          </p:cNvPr>
          <p:cNvSpPr txBox="1"/>
          <p:nvPr/>
        </p:nvSpPr>
        <p:spPr>
          <a:xfrm>
            <a:off x="118581" y="461048"/>
            <a:ext cx="5173147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TW" b="1" dirty="0">
                <a:latin typeface="Arial" pitchFamily="34" charset="0"/>
                <a:cs typeface="Arial" pitchFamily="34" charset="0"/>
              </a:rPr>
              <a:t>Table S3 : Antibody used in the present study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28C2BD96-8E05-1CA3-7D9A-32778A0262A2}"/>
              </a:ext>
            </a:extLst>
          </p:cNvPr>
          <p:cNvSpPr txBox="1"/>
          <p:nvPr/>
        </p:nvSpPr>
        <p:spPr>
          <a:xfrm>
            <a:off x="119031" y="1511301"/>
            <a:ext cx="22320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/>
              <a:t>Primary Antibodies</a:t>
            </a:r>
            <a:endParaRPr lang="zh-TW" altLang="en-US" sz="2000" b="1" dirty="0"/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7A25B447-B530-75EE-C802-2A6C1263D903}"/>
              </a:ext>
            </a:extLst>
          </p:cNvPr>
          <p:cNvSpPr txBox="1"/>
          <p:nvPr/>
        </p:nvSpPr>
        <p:spPr>
          <a:xfrm>
            <a:off x="118581" y="7355680"/>
            <a:ext cx="25049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dirty="0"/>
              <a:t>Secondary Antibodies</a:t>
            </a:r>
            <a:endParaRPr lang="zh-TW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045017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6</TotalTime>
  <Words>289</Words>
  <Application>Microsoft Office PowerPoint</Application>
  <PresentationFormat>寬螢幕</PresentationFormat>
  <Paragraphs>137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Office 佈景主題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黎萬君</dc:creator>
  <cp:lastModifiedBy>黎萬君</cp:lastModifiedBy>
  <cp:revision>12</cp:revision>
  <dcterms:created xsi:type="dcterms:W3CDTF">2023-08-09T14:51:51Z</dcterms:created>
  <dcterms:modified xsi:type="dcterms:W3CDTF">2023-10-14T17:32:43Z</dcterms:modified>
</cp:coreProperties>
</file>